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7" r:id="rId2"/>
  </p:sldIdLst>
  <p:sldSz cx="12192000" cy="121618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808CE9B-F357-9D4F-AE1C-03B048A59DB2}" v="1" dt="2024-03-04T17:11:55.51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98" autoAdjust="0"/>
    <p:restoredTop sz="96327"/>
  </p:normalViewPr>
  <p:slideViewPr>
    <p:cSldViewPr snapToGrid="0">
      <p:cViewPr varScale="1">
        <p:scale>
          <a:sx n="72" d="100"/>
          <a:sy n="72" d="100"/>
        </p:scale>
        <p:origin x="944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dre, Gustavo (NIH/NHGRI) [E]" userId="7cb92407-7ea6-47e7-b04d-6a69c5a3d77e" providerId="ADAL" clId="{3808CE9B-F357-9D4F-AE1C-03B048A59DB2}"/>
    <pc:docChg chg="custSel modSld">
      <pc:chgData name="Sudre, Gustavo (NIH/NHGRI) [E]" userId="7cb92407-7ea6-47e7-b04d-6a69c5a3d77e" providerId="ADAL" clId="{3808CE9B-F357-9D4F-AE1C-03B048A59DB2}" dt="2024-03-04T17:12:11.002" v="4" actId="1076"/>
      <pc:docMkLst>
        <pc:docMk/>
      </pc:docMkLst>
      <pc:sldChg chg="addSp delSp modSp mod">
        <pc:chgData name="Sudre, Gustavo (NIH/NHGRI) [E]" userId="7cb92407-7ea6-47e7-b04d-6a69c5a3d77e" providerId="ADAL" clId="{3808CE9B-F357-9D4F-AE1C-03B048A59DB2}" dt="2024-03-04T17:12:11.002" v="4" actId="1076"/>
        <pc:sldMkLst>
          <pc:docMk/>
          <pc:sldMk cId="2726606352" sldId="287"/>
        </pc:sldMkLst>
        <pc:grpChg chg="del">
          <ac:chgData name="Sudre, Gustavo (NIH/NHGRI) [E]" userId="7cb92407-7ea6-47e7-b04d-6a69c5a3d77e" providerId="ADAL" clId="{3808CE9B-F357-9D4F-AE1C-03B048A59DB2}" dt="2024-03-04T17:12:02.098" v="1" actId="478"/>
          <ac:grpSpMkLst>
            <pc:docMk/>
            <pc:sldMk cId="2726606352" sldId="287"/>
            <ac:grpSpMk id="3" creationId="{720C9C7E-0EA2-E8A8-7AEB-9DA8E82AB35D}"/>
          </ac:grpSpMkLst>
        </pc:grpChg>
        <pc:picChg chg="add mod">
          <ac:chgData name="Sudre, Gustavo (NIH/NHGRI) [E]" userId="7cb92407-7ea6-47e7-b04d-6a69c5a3d77e" providerId="ADAL" clId="{3808CE9B-F357-9D4F-AE1C-03B048A59DB2}" dt="2024-03-04T17:12:11.002" v="4" actId="1076"/>
          <ac:picMkLst>
            <pc:docMk/>
            <pc:sldMk cId="2726606352" sldId="287"/>
            <ac:picMk id="7" creationId="{9D482E12-6C7B-0960-ABA8-DB3BF1D38FF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990376"/>
            <a:ext cx="10363200" cy="4234121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387781"/>
            <a:ext cx="9144000" cy="2936295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564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7405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47505"/>
            <a:ext cx="2628900" cy="1030659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47505"/>
            <a:ext cx="7734300" cy="1030659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434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802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032017"/>
            <a:ext cx="10515600" cy="5058986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8138863"/>
            <a:ext cx="10515600" cy="2660401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408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237527"/>
            <a:ext cx="5181600" cy="77165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237527"/>
            <a:ext cx="5181600" cy="77165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2103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47508"/>
            <a:ext cx="10515600" cy="235072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981340"/>
            <a:ext cx="5157787" cy="146110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442449"/>
            <a:ext cx="5157787" cy="65341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981340"/>
            <a:ext cx="5183188" cy="146110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442449"/>
            <a:ext cx="5183188" cy="653417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344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249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214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10789"/>
            <a:ext cx="3932237" cy="283776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751082"/>
            <a:ext cx="6172200" cy="8642788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648551"/>
            <a:ext cx="3932237" cy="675939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748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10789"/>
            <a:ext cx="3932237" cy="283776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751082"/>
            <a:ext cx="6172200" cy="8642788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648551"/>
            <a:ext cx="3932237" cy="675939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910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47508"/>
            <a:ext cx="10515600" cy="23507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237527"/>
            <a:ext cx="10515600" cy="77165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1272225"/>
            <a:ext cx="2743200" cy="6475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DB2AF-294F-4085-A16F-B72C5567E765}" type="datetimeFigureOut">
              <a:rPr lang="en-US" smtClean="0"/>
              <a:t>3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1272225"/>
            <a:ext cx="4114800" cy="6475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1272225"/>
            <a:ext cx="2743200" cy="64750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14E0BE-DC5D-47F7-B791-AC29A5D3C8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253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5C3074C-BD3C-ED4F-AF25-425D05C3403D}"/>
              </a:ext>
            </a:extLst>
          </p:cNvPr>
          <p:cNvSpPr txBox="1"/>
          <p:nvPr/>
        </p:nvSpPr>
        <p:spPr>
          <a:xfrm>
            <a:off x="1161535" y="6338455"/>
            <a:ext cx="104970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 figure 2.  Results for the AUKRC gene is shown given (which was showed significant correlation </a:t>
            </a:r>
            <a:r>
              <a:rPr lang="en-US"/>
              <a:t>betw</a:t>
            </a:r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9D482E12-6C7B-0960-ABA8-DB3BF1D38F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6105" y="799645"/>
            <a:ext cx="10399790" cy="50237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6606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684</TotalTime>
  <Words>19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Gauri Shastri</dc:creator>
  <cp:lastModifiedBy>Sudre, Gustavo (NIH/NHGRI) [E]</cp:lastModifiedBy>
  <cp:revision>23</cp:revision>
  <dcterms:created xsi:type="dcterms:W3CDTF">2023-06-12T15:10:16Z</dcterms:created>
  <dcterms:modified xsi:type="dcterms:W3CDTF">2024-03-04T17:12:15Z</dcterms:modified>
</cp:coreProperties>
</file>